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D794F4-E24B-4C3A-8DE7-8644BA2523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8C3AD24-262E-48BC-A448-191201D62E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BA800E-ADA8-477B-BBFC-0A7F899F0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49F798-FD2B-4130-ACB2-CCA3DC4B6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38B6BB-288D-4171-BBDA-DBC99E46E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8331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29BC7A-9904-4420-A177-0B4824DBF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F283BAE-8F74-410B-9C96-6E81A5ADDF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A8226A-468B-4546-BA59-89A6AE4B9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1E441E-A9B1-4774-BC4F-BBA3F67BA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CB4BFE2-0F35-40C6-B2C3-D3D9A0705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27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5869236-FDC7-4D96-8AED-B5D7E7581F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3B1EF50-7D2A-4748-B2F2-FC4D98C17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E807BD-4786-4C20-8062-8D30011E4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E7DCFD0-A0D1-4347-BA44-13D984572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CFA070-029E-4735-BE88-D500ECF1C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512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CB7339-993D-4FA5-983D-A25565452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B47DAD3-E5E8-4B77-90EE-85559A52A9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B53BDF-81F5-4F8F-AFDF-5A6B4AA9F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29D9C04-42B6-4127-9843-4FA0C6F18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7C614B-1C4C-4D6D-A0D8-F1F0E9002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9189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0A6805-5391-4E95-9FE0-B47BF988E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9AFC12C-9152-4F98-A17C-9BB4D51F8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70902CD-EFDF-4875-A521-8B4E3D081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727A39-7441-4A35-9BE0-EA2CC1AF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C4AE2E-7F80-4136-9A9D-8495C05E6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0263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3131A7-59FC-4143-AFB9-61D62FBD4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1187DF-B6CE-419F-8591-FEA7CB0077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F17C53F-EEBA-44A4-93C4-45FE81163A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7F3DFA8-CF3D-439D-A4ED-78C2E8B4A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EE11231-4D9E-4E7E-BCD9-29E577E60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8DBCEE-06D6-45E6-A437-9A13B38B5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1937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1A5D13-433A-4C32-9377-E9E9CB814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96B9F03-B5D8-4411-AF29-0D6DBB765C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034E265-D882-4DF4-9616-C77492F73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956D15D-844B-41D2-9C3C-C28AA875E6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E304CC8-348C-4DCE-9D90-43DADF4939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86BCF52-C358-43AA-9AF6-40F6D0FA0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0C02941-E7D3-4F3A-818E-FBF43D25A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6C21B59-AC8C-4F42-BA4D-4BBDEDCC5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8302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2FCBAB-BD40-4C04-B815-B861D7474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F55B1DB-BEA0-4D8A-8F3D-EFFDFA5EC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3D4AA13-C723-47DD-AE5D-73E7DA4F3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2C6CC98-7162-4B63-9D10-73387AAD3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505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E06B809-293D-4A41-980C-41F6E8EC7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2783A2A-84E3-4E5D-BC51-18D66AE27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3C0139A-BD26-4D58-BA2D-4C4FFB2E1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991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2F73F1-1F5E-47BE-9822-7E8D75CBF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CAA0D1B-CF27-4B03-819E-D30A047BDB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27CEC52-2772-4F6A-9ACB-43562950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39EC593-D518-4752-8BF9-36A51FC5E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1BF9124-C299-487E-87F0-5104F3027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9D7E7BC-F925-4847-8636-7370A4F22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729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A4B86D-21AE-459A-B75D-444345B57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4E9E3C4-9994-458F-B88B-3D1EB2F14B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D3254EA-5F8A-467F-ADC6-16F1533EE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25A3CAB-D840-486C-9249-BEE944D01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007D05F-2401-4BE9-A2C9-29E32A695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8EC34F3-15C8-479A-90C6-70CE0D646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53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B40E1D7-86FC-4335-BC71-47C3751E9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FB86F34-1E8F-4059-B9E8-231681B13B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3D2838-EAC2-4351-93C6-833B38925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096AB80-D735-4F56-B486-DFADE9AD9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C81C39-724B-4D61-BD6A-9A3850C71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617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10">
            <a:extLst>
              <a:ext uri="{FF2B5EF4-FFF2-40B4-BE49-F238E27FC236}">
                <a16:creationId xmlns:a16="http://schemas.microsoft.com/office/drawing/2014/main" id="{F10963EC-E61A-4426-96BA-DCBC3819E0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12194" y="207261"/>
            <a:ext cx="55335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 S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36B68651-78D8-41C3-97F3-8DC5606F9F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67871" y="1195972"/>
            <a:ext cx="1977513" cy="236434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A6E5FC0-8E99-4A35-9F45-3A57135085E9}"/>
              </a:ext>
            </a:extLst>
          </p:cNvPr>
          <p:cNvSpPr txBox="1"/>
          <p:nvPr/>
        </p:nvSpPr>
        <p:spPr>
          <a:xfrm>
            <a:off x="7938690" y="837012"/>
            <a:ext cx="2111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d-Gal4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&gt; 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UAS-mCD8GFP</a:t>
            </a:r>
            <a:endParaRPr lang="ko-KR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BCD7A7C-5BE2-4FEC-9A95-F43470B09DB8}"/>
              </a:ext>
            </a:extLst>
          </p:cNvPr>
          <p:cNvSpPr txBox="1"/>
          <p:nvPr/>
        </p:nvSpPr>
        <p:spPr>
          <a:xfrm>
            <a:off x="1972434" y="162502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D6B6F87-652B-4FF4-BFDD-7495EABB041D}"/>
              </a:ext>
            </a:extLst>
          </p:cNvPr>
          <p:cNvSpPr txBox="1"/>
          <p:nvPr/>
        </p:nvSpPr>
        <p:spPr>
          <a:xfrm>
            <a:off x="4714483" y="162502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B1F96B5-A78F-4CC5-9D50-C236CEC57173}"/>
              </a:ext>
            </a:extLst>
          </p:cNvPr>
          <p:cNvSpPr txBox="1"/>
          <p:nvPr/>
        </p:nvSpPr>
        <p:spPr>
          <a:xfrm>
            <a:off x="7938690" y="1217429"/>
            <a:ext cx="7585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uthpart</a:t>
            </a:r>
            <a:endParaRPr lang="ko-KR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69703D4D-A2D5-42B5-898A-DC748A6B819C}"/>
              </a:ext>
            </a:extLst>
          </p:cNvPr>
          <p:cNvCxnSpPr/>
          <p:nvPr/>
        </p:nvCxnSpPr>
        <p:spPr>
          <a:xfrm flipH="1">
            <a:off x="8543934" y="1268261"/>
            <a:ext cx="153296" cy="334334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그림 31">
            <a:extLst>
              <a:ext uri="{FF2B5EF4-FFF2-40B4-BE49-F238E27FC236}">
                <a16:creationId xmlns:a16="http://schemas.microsoft.com/office/drawing/2014/main" id="{8F98FE4E-C5E4-491F-8D8C-D9E1C07FF4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0109" y="2041663"/>
            <a:ext cx="2034038" cy="1235263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C735B7FF-9628-4201-A42F-7A345374E5F7}"/>
              </a:ext>
            </a:extLst>
          </p:cNvPr>
          <p:cNvSpPr txBox="1"/>
          <p:nvPr/>
        </p:nvSpPr>
        <p:spPr>
          <a:xfrm rot="16200000">
            <a:off x="1559301" y="2526329"/>
            <a:ext cx="10246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% Response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0BC1338-A444-49AB-9E11-B4CAE14F4ABC}"/>
              </a:ext>
            </a:extLst>
          </p:cNvPr>
          <p:cNvSpPr txBox="1"/>
          <p:nvPr/>
        </p:nvSpPr>
        <p:spPr>
          <a:xfrm>
            <a:off x="2099480" y="202248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77E0813-B083-416B-8EC3-9C4B230E1E49}"/>
              </a:ext>
            </a:extLst>
          </p:cNvPr>
          <p:cNvSpPr txBox="1"/>
          <p:nvPr/>
        </p:nvSpPr>
        <p:spPr>
          <a:xfrm>
            <a:off x="2152379" y="22272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B6251FA-A44F-4BA5-B7BA-220987572C7A}"/>
              </a:ext>
            </a:extLst>
          </p:cNvPr>
          <p:cNvSpPr txBox="1"/>
          <p:nvPr/>
        </p:nvSpPr>
        <p:spPr>
          <a:xfrm>
            <a:off x="2152379" y="24546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44B80D0-5C80-4601-A02A-76350B84B146}"/>
              </a:ext>
            </a:extLst>
          </p:cNvPr>
          <p:cNvSpPr txBox="1"/>
          <p:nvPr/>
        </p:nvSpPr>
        <p:spPr>
          <a:xfrm>
            <a:off x="2152379" y="267646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CA53E6B-2C53-4EF3-A6EE-9172F7E5A928}"/>
              </a:ext>
            </a:extLst>
          </p:cNvPr>
          <p:cNvSpPr txBox="1"/>
          <p:nvPr/>
        </p:nvSpPr>
        <p:spPr>
          <a:xfrm>
            <a:off x="2152379" y="28982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A7361D4-737C-42B6-8F0C-AC1E35A39F5D}"/>
              </a:ext>
            </a:extLst>
          </p:cNvPr>
          <p:cNvSpPr txBox="1"/>
          <p:nvPr/>
        </p:nvSpPr>
        <p:spPr>
          <a:xfrm>
            <a:off x="2185817" y="310530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BF7B007-A650-4FF9-B178-A92FE1DDEB57}"/>
              </a:ext>
            </a:extLst>
          </p:cNvPr>
          <p:cNvSpPr txBox="1"/>
          <p:nvPr/>
        </p:nvSpPr>
        <p:spPr>
          <a:xfrm>
            <a:off x="2662766" y="3254910"/>
            <a:ext cx="45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17D1789-7520-4A8A-8B1A-2CC427CD7DE6}"/>
              </a:ext>
            </a:extLst>
          </p:cNvPr>
          <p:cNvSpPr txBox="1"/>
          <p:nvPr/>
        </p:nvSpPr>
        <p:spPr>
          <a:xfrm>
            <a:off x="3150928" y="3254910"/>
            <a:ext cx="45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0290778-6130-48AB-919C-FBA4A1E9FF66}"/>
              </a:ext>
            </a:extLst>
          </p:cNvPr>
          <p:cNvSpPr txBox="1"/>
          <p:nvPr/>
        </p:nvSpPr>
        <p:spPr>
          <a:xfrm>
            <a:off x="3554747" y="3254909"/>
            <a:ext cx="423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BC063CD-2305-4534-8A12-F9AEFB9F1FD6}"/>
              </a:ext>
            </a:extLst>
          </p:cNvPr>
          <p:cNvSpPr txBox="1"/>
          <p:nvPr/>
        </p:nvSpPr>
        <p:spPr>
          <a:xfrm>
            <a:off x="4053592" y="3254909"/>
            <a:ext cx="423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F8405A0-7C26-44D6-9D6C-2895A6DEF124}"/>
              </a:ext>
            </a:extLst>
          </p:cNvPr>
          <p:cNvSpPr txBox="1"/>
          <p:nvPr/>
        </p:nvSpPr>
        <p:spPr>
          <a:xfrm>
            <a:off x="2934613" y="3430218"/>
            <a:ext cx="11795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apsaicin (mM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그림 45">
            <a:extLst>
              <a:ext uri="{FF2B5EF4-FFF2-40B4-BE49-F238E27FC236}">
                <a16:creationId xmlns:a16="http://schemas.microsoft.com/office/drawing/2014/main" id="{066F4147-DA31-4B09-9DD5-754F36E167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5701" y="2111588"/>
            <a:ext cx="1999119" cy="1265818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463DAF89-525D-49BB-9A7B-8D59FAC807DC}"/>
              </a:ext>
            </a:extLst>
          </p:cNvPr>
          <p:cNvSpPr txBox="1"/>
          <p:nvPr/>
        </p:nvSpPr>
        <p:spPr>
          <a:xfrm>
            <a:off x="4864751" y="207531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5872AFC-A184-4831-83C7-5F6876A9B25F}"/>
              </a:ext>
            </a:extLst>
          </p:cNvPr>
          <p:cNvSpPr txBox="1"/>
          <p:nvPr/>
        </p:nvSpPr>
        <p:spPr>
          <a:xfrm>
            <a:off x="4907140" y="23131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4B04C4E-B41F-4CB7-ACF2-C420B7C21FC5}"/>
              </a:ext>
            </a:extLst>
          </p:cNvPr>
          <p:cNvSpPr txBox="1"/>
          <p:nvPr/>
        </p:nvSpPr>
        <p:spPr>
          <a:xfrm>
            <a:off x="4907140" y="254643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62FFF50-7BD9-4F31-BDA7-A50D8E57F24A}"/>
              </a:ext>
            </a:extLst>
          </p:cNvPr>
          <p:cNvSpPr txBox="1"/>
          <p:nvPr/>
        </p:nvSpPr>
        <p:spPr>
          <a:xfrm>
            <a:off x="4907140" y="278012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5512CAA-BA87-4C5B-88E9-E985E839AA59}"/>
              </a:ext>
            </a:extLst>
          </p:cNvPr>
          <p:cNvSpPr txBox="1"/>
          <p:nvPr/>
        </p:nvSpPr>
        <p:spPr>
          <a:xfrm>
            <a:off x="4907140" y="29900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07F40B2-BF14-433C-A4C6-B821884783D4}"/>
              </a:ext>
            </a:extLst>
          </p:cNvPr>
          <p:cNvSpPr txBox="1"/>
          <p:nvPr/>
        </p:nvSpPr>
        <p:spPr>
          <a:xfrm>
            <a:off x="4960039" y="319377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6FE4E74-5E0A-4DC4-AC10-E9905BA46762}"/>
              </a:ext>
            </a:extLst>
          </p:cNvPr>
          <p:cNvSpPr txBox="1"/>
          <p:nvPr/>
        </p:nvSpPr>
        <p:spPr>
          <a:xfrm rot="16200000">
            <a:off x="4328529" y="2606369"/>
            <a:ext cx="10246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% Response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443CE31-2672-4AB8-85E4-9FAE49190639}"/>
              </a:ext>
            </a:extLst>
          </p:cNvPr>
          <p:cNvSpPr txBox="1"/>
          <p:nvPr/>
        </p:nvSpPr>
        <p:spPr>
          <a:xfrm>
            <a:off x="5551695" y="3418342"/>
            <a:ext cx="5354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ko-KR" sz="11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1118</a:t>
            </a:r>
            <a:endParaRPr lang="ko-KR" altLang="en-US" sz="11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B300A87-CEF4-4F72-953F-4957607256C2}"/>
              </a:ext>
            </a:extLst>
          </p:cNvPr>
          <p:cNvSpPr txBox="1"/>
          <p:nvPr/>
        </p:nvSpPr>
        <p:spPr>
          <a:xfrm>
            <a:off x="6276331" y="3418342"/>
            <a:ext cx="11795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)</a:t>
            </a:r>
            <a:endParaRPr lang="ko-KR" altLang="en-U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그림 55">
            <a:extLst>
              <a:ext uri="{FF2B5EF4-FFF2-40B4-BE49-F238E27FC236}">
                <a16:creationId xmlns:a16="http://schemas.microsoft.com/office/drawing/2014/main" id="{3E446AD2-9EC4-4B72-93A8-A214CC312C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25016" y="1619088"/>
            <a:ext cx="208268" cy="302936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36C22EE2-1F1A-45CE-8907-00316682D8D5}"/>
              </a:ext>
            </a:extLst>
          </p:cNvPr>
          <p:cNvSpPr txBox="1"/>
          <p:nvPr/>
        </p:nvSpPr>
        <p:spPr>
          <a:xfrm>
            <a:off x="5551695" y="1358584"/>
            <a:ext cx="11795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apsaicin (mM) 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F001B89-02A9-4DB6-AD25-2417F16203C2}"/>
              </a:ext>
            </a:extLst>
          </p:cNvPr>
          <p:cNvSpPr txBox="1"/>
          <p:nvPr/>
        </p:nvSpPr>
        <p:spPr>
          <a:xfrm>
            <a:off x="6009374" y="1564496"/>
            <a:ext cx="11795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A0DA44D-6216-4DB3-B803-76F750754739}"/>
              </a:ext>
            </a:extLst>
          </p:cNvPr>
          <p:cNvSpPr txBox="1"/>
          <p:nvPr/>
        </p:nvSpPr>
        <p:spPr>
          <a:xfrm>
            <a:off x="6009374" y="1706340"/>
            <a:ext cx="11795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BC23E0F-1AA4-493A-9B00-FB38002066DB}"/>
              </a:ext>
            </a:extLst>
          </p:cNvPr>
          <p:cNvSpPr txBox="1"/>
          <p:nvPr/>
        </p:nvSpPr>
        <p:spPr>
          <a:xfrm>
            <a:off x="7531350" y="86664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 Box 28">
            <a:extLst>
              <a:ext uri="{FF2B5EF4-FFF2-40B4-BE49-F238E27FC236}">
                <a16:creationId xmlns:a16="http://schemas.microsoft.com/office/drawing/2014/main" id="{909EBE9E-2F7F-4928-A32C-D1DB2C50A1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82294" y="1955650"/>
            <a:ext cx="39626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7ABD48B5-8995-4DC5-BFCD-5EE3B34EAD28}"/>
              </a:ext>
            </a:extLst>
          </p:cNvPr>
          <p:cNvSpPr/>
          <p:nvPr/>
        </p:nvSpPr>
        <p:spPr>
          <a:xfrm>
            <a:off x="3447570" y="848888"/>
            <a:ext cx="22894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b="1" dirty="0">
                <a:solidFill>
                  <a:srgbClr val="000000"/>
                </a:solidFill>
                <a:latin typeface="Arial" panose="020B0604020202020204" pitchFamily="34" charset="0"/>
                <a:ea typeface="바탕" panose="02030600000101010101" pitchFamily="18" charset="-127"/>
                <a:cs typeface="Arial" panose="020B0604020202020204" pitchFamily="34" charset="0"/>
              </a:rPr>
              <a:t>Nociceptive rolling response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직선 연결선 3">
            <a:extLst>
              <a:ext uri="{FF2B5EF4-FFF2-40B4-BE49-F238E27FC236}">
                <a16:creationId xmlns:a16="http://schemas.microsoft.com/office/drawing/2014/main" id="{201DF1A0-71D7-4E56-8332-67FB75AFF2CD}"/>
              </a:ext>
            </a:extLst>
          </p:cNvPr>
          <p:cNvCxnSpPr/>
          <p:nvPr/>
        </p:nvCxnSpPr>
        <p:spPr>
          <a:xfrm>
            <a:off x="2116063" y="1175116"/>
            <a:ext cx="47869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 Box 28">
            <a:extLst>
              <a:ext uri="{FF2B5EF4-FFF2-40B4-BE49-F238E27FC236}">
                <a16:creationId xmlns:a16="http://schemas.microsoft.com/office/drawing/2014/main" id="{F85448A8-84B5-4A9D-A945-163C4D4CAC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9302" y="1864606"/>
            <a:ext cx="39626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CB02CD2B-000B-48BF-83A0-196E6407AAF3}"/>
              </a:ext>
            </a:extLst>
          </p:cNvPr>
          <p:cNvSpPr/>
          <p:nvPr/>
        </p:nvSpPr>
        <p:spPr>
          <a:xfrm>
            <a:off x="2815258" y="1536716"/>
            <a:ext cx="1426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solidFill>
                  <a:srgbClr val="000000"/>
                </a:solidFill>
                <a:latin typeface="Arial" panose="020B0604020202020204" pitchFamily="34" charset="0"/>
                <a:ea typeface="바탕" panose="02030600000101010101" pitchFamily="18" charset="-127"/>
                <a:cs typeface="Arial" panose="020B0604020202020204" pitchFamily="34" charset="0"/>
              </a:rPr>
              <a:t>md-TRPV1(3)</a:t>
            </a:r>
            <a:r>
              <a:rPr lang="en-US" altLang="ko-KR" sz="1000" b="1" dirty="0">
                <a:solidFill>
                  <a:srgbClr val="000000"/>
                </a:solidFill>
                <a:latin typeface="Arial" panose="020B0604020202020204" pitchFamily="34" charset="0"/>
                <a:ea typeface="바탕" panose="02030600000101010101" pitchFamily="18" charset="-127"/>
                <a:cs typeface="Arial" panose="020B0604020202020204" pitchFamily="34" charset="0"/>
              </a:rPr>
              <a:t> larvae 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306360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</TotalTime>
  <Words>50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aranya Siva</cp:lastModifiedBy>
  <cp:revision>149</cp:revision>
  <dcterms:created xsi:type="dcterms:W3CDTF">2022-10-18T02:31:52Z</dcterms:created>
  <dcterms:modified xsi:type="dcterms:W3CDTF">2023-02-08T08:33:22Z</dcterms:modified>
</cp:coreProperties>
</file>